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7" d="100"/>
          <a:sy n="87" d="100"/>
        </p:scale>
        <p:origin x="52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4DDEC-FA14-4337-A740-630A9BF1603A}" type="datetimeFigureOut">
              <a:rPr lang="en-IN" smtClean="0"/>
              <a:t>17-04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C4A10-3163-4A7C-B012-F48C637850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391790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4DDEC-FA14-4337-A740-630A9BF1603A}" type="datetimeFigureOut">
              <a:rPr lang="en-IN" smtClean="0"/>
              <a:t>17-04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C4A10-3163-4A7C-B012-F48C637850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288681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4DDEC-FA14-4337-A740-630A9BF1603A}" type="datetimeFigureOut">
              <a:rPr lang="en-IN" smtClean="0"/>
              <a:t>17-04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C4A10-3163-4A7C-B012-F48C637850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029326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4DDEC-FA14-4337-A740-630A9BF1603A}" type="datetimeFigureOut">
              <a:rPr lang="en-IN" smtClean="0"/>
              <a:t>17-04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C4A10-3163-4A7C-B012-F48C637850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076026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4DDEC-FA14-4337-A740-630A9BF1603A}" type="datetimeFigureOut">
              <a:rPr lang="en-IN" smtClean="0"/>
              <a:t>17-04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C4A10-3163-4A7C-B012-F48C637850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28396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4DDEC-FA14-4337-A740-630A9BF1603A}" type="datetimeFigureOut">
              <a:rPr lang="en-IN" smtClean="0"/>
              <a:t>17-04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C4A10-3163-4A7C-B012-F48C637850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92119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4DDEC-FA14-4337-A740-630A9BF1603A}" type="datetimeFigureOut">
              <a:rPr lang="en-IN" smtClean="0"/>
              <a:t>17-04-2026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C4A10-3163-4A7C-B012-F48C637850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83435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4DDEC-FA14-4337-A740-630A9BF1603A}" type="datetimeFigureOut">
              <a:rPr lang="en-IN" smtClean="0"/>
              <a:t>17-04-2026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C4A10-3163-4A7C-B012-F48C637850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49289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4DDEC-FA14-4337-A740-630A9BF1603A}" type="datetimeFigureOut">
              <a:rPr lang="en-IN" smtClean="0"/>
              <a:t>17-04-2026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C4A10-3163-4A7C-B012-F48C637850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318831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4DDEC-FA14-4337-A740-630A9BF1603A}" type="datetimeFigureOut">
              <a:rPr lang="en-IN" smtClean="0"/>
              <a:t>17-04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C4A10-3163-4A7C-B012-F48C637850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23891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B4DDEC-FA14-4337-A740-630A9BF1603A}" type="datetimeFigureOut">
              <a:rPr lang="en-IN" smtClean="0"/>
              <a:t>17-04-20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C4A10-3163-4A7C-B012-F48C637850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84259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B4DDEC-FA14-4337-A740-630A9BF1603A}" type="datetimeFigureOut">
              <a:rPr lang="en-IN" smtClean="0"/>
              <a:t>17-04-20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C4A10-3163-4A7C-B012-F48C637850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966293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FA00909-D483-8DC2-11BF-7978C1CA8DC8}"/>
              </a:ext>
            </a:extLst>
          </p:cNvPr>
          <p:cNvSpPr txBox="1"/>
          <p:nvPr/>
        </p:nvSpPr>
        <p:spPr>
          <a:xfrm>
            <a:off x="3772690" y="92713"/>
            <a:ext cx="1431289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46" dirty="0"/>
              <a:t>Supporting figure 1</a:t>
            </a:r>
            <a:endParaRPr kumimoji="1" lang="ja-JP" altLang="en-US" sz="1246" dirty="0"/>
          </a:p>
        </p:txBody>
      </p: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A6223C60-883A-73E1-9C03-0CA240E83F6C}"/>
              </a:ext>
            </a:extLst>
          </p:cNvPr>
          <p:cNvGrpSpPr/>
          <p:nvPr/>
        </p:nvGrpSpPr>
        <p:grpSpPr>
          <a:xfrm>
            <a:off x="3795008" y="734926"/>
            <a:ext cx="2444751" cy="1981160"/>
            <a:chOff x="211366" y="1061559"/>
            <a:chExt cx="4955000" cy="3672692"/>
          </a:xfrm>
        </p:grpSpPr>
        <p:pic>
          <p:nvPicPr>
            <p:cNvPr id="5" name="図 4" descr="グラフ, 折れ線グラフ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9EDE27D7-0677-7EA5-2784-0953F158DE4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15419" b="16415"/>
            <a:stretch>
              <a:fillRect/>
            </a:stretch>
          </p:blipFill>
          <p:spPr>
            <a:xfrm>
              <a:off x="1020593" y="1587128"/>
              <a:ext cx="3838633" cy="2576500"/>
            </a:xfrm>
            <a:prstGeom prst="rect">
              <a:avLst/>
            </a:prstGeom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E5F27C32-1B64-E83B-0935-E5F091131D8B}"/>
                </a:ext>
              </a:extLst>
            </p:cNvPr>
            <p:cNvSpPr txBox="1"/>
            <p:nvPr/>
          </p:nvSpPr>
          <p:spPr>
            <a:xfrm>
              <a:off x="1317416" y="4355661"/>
              <a:ext cx="3275595" cy="3785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27" b="1" dirty="0">
                  <a:latin typeface="Arial" panose="020B0604020202020204" pitchFamily="34" charset="0"/>
                  <a:cs typeface="Arial" panose="020B0604020202020204" pitchFamily="34" charset="0"/>
                </a:rPr>
                <a:t>Progression-free survival (Days)</a:t>
              </a:r>
              <a:endParaRPr kumimoji="1" lang="ja-JP" altLang="en-US" sz="727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13E37FC5-D2D7-80EB-EFDA-EFF95E22D1DD}"/>
                </a:ext>
              </a:extLst>
            </p:cNvPr>
            <p:cNvSpPr txBox="1"/>
            <p:nvPr/>
          </p:nvSpPr>
          <p:spPr>
            <a:xfrm>
              <a:off x="1397590" y="1061559"/>
              <a:ext cx="3402304" cy="3885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62" i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D-L1 in macrophage High </a:t>
              </a:r>
              <a:r>
                <a:rPr kumimoji="1" lang="en-US" altLang="ja-JP" sz="762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 = 3)</a:t>
              </a:r>
              <a:endParaRPr kumimoji="1" lang="ja-JP" altLang="en-US" sz="762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0849DF2B-E46E-7DEC-BE62-4C5743EFACE0}"/>
                </a:ext>
              </a:extLst>
            </p:cNvPr>
            <p:cNvSpPr txBox="1"/>
            <p:nvPr/>
          </p:nvSpPr>
          <p:spPr>
            <a:xfrm>
              <a:off x="1224735" y="1305151"/>
              <a:ext cx="3941631" cy="3885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62" i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D-L1 in macrophage Moderate </a:t>
              </a:r>
              <a:r>
                <a:rPr kumimoji="1" lang="en-US" altLang="ja-JP" sz="762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 = 12)</a:t>
              </a:r>
              <a:endParaRPr kumimoji="1" lang="ja-JP" altLang="en-US" sz="762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C8D57EAD-A3AF-9BDB-5F2A-BC181305CCEC}"/>
                </a:ext>
              </a:extLst>
            </p:cNvPr>
            <p:cNvSpPr txBox="1"/>
            <p:nvPr/>
          </p:nvSpPr>
          <p:spPr>
            <a:xfrm rot="10800000">
              <a:off x="211366" y="2002771"/>
              <a:ext cx="601057" cy="177586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kumimoji="1" lang="en-US" altLang="ja-JP" sz="727" b="1" dirty="0">
                  <a:latin typeface="Arial" panose="020B0604020202020204" pitchFamily="34" charset="0"/>
                  <a:cs typeface="Arial" panose="020B0604020202020204" pitchFamily="34" charset="0"/>
                </a:rPr>
                <a:t>Survival probability</a:t>
              </a:r>
              <a:endParaRPr kumimoji="1" lang="ja-JP" altLang="en-US" sz="727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 Box 236">
              <a:extLst>
                <a:ext uri="{FF2B5EF4-FFF2-40B4-BE49-F238E27FC236}">
                  <a16:creationId xmlns:a16="http://schemas.microsoft.com/office/drawing/2014/main" id="{366EC769-0D93-438F-4497-AF865A22D8B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86298" y="2046085"/>
              <a:ext cx="1108545" cy="3885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762" b="1" i="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p = 0.85</a:t>
              </a:r>
              <a:endParaRPr lang="en-US" altLang="ja-JP" sz="762" b="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12" name="Rectangle 49">
              <a:extLst>
                <a:ext uri="{FF2B5EF4-FFF2-40B4-BE49-F238E27FC236}">
                  <a16:creationId xmlns:a16="http://schemas.microsoft.com/office/drawing/2014/main" id="{52B04243-EED4-576C-2320-A7F19DAE26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2923" y="1604332"/>
              <a:ext cx="436151" cy="2174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762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1.0</a:t>
              </a:r>
              <a:endParaRPr lang="ja-JP" altLang="en-US" sz="762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13" name="Rectangle 49">
              <a:extLst>
                <a:ext uri="{FF2B5EF4-FFF2-40B4-BE49-F238E27FC236}">
                  <a16:creationId xmlns:a16="http://schemas.microsoft.com/office/drawing/2014/main" id="{0DE1A20E-9149-14F8-196B-A3D827F49D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1919" y="2100689"/>
              <a:ext cx="436151" cy="2174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762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.8</a:t>
              </a:r>
              <a:endParaRPr lang="ja-JP" altLang="en-US" sz="762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14" name="Rectangle 49">
              <a:extLst>
                <a:ext uri="{FF2B5EF4-FFF2-40B4-BE49-F238E27FC236}">
                  <a16:creationId xmlns:a16="http://schemas.microsoft.com/office/drawing/2014/main" id="{0A30B8FE-2BFF-AC9F-91B1-06B66848A9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1919" y="2575885"/>
              <a:ext cx="436151" cy="2174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762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.6</a:t>
              </a:r>
              <a:endParaRPr lang="ja-JP" altLang="en-US" sz="762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15" name="Rectangle 49">
              <a:extLst>
                <a:ext uri="{FF2B5EF4-FFF2-40B4-BE49-F238E27FC236}">
                  <a16:creationId xmlns:a16="http://schemas.microsoft.com/office/drawing/2014/main" id="{E651880E-B400-D9B4-9971-CA74811B68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8954" y="3041158"/>
              <a:ext cx="436151" cy="2174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762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.4</a:t>
              </a:r>
              <a:endParaRPr lang="ja-JP" altLang="en-US" sz="762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16" name="Rectangle 49">
              <a:extLst>
                <a:ext uri="{FF2B5EF4-FFF2-40B4-BE49-F238E27FC236}">
                  <a16:creationId xmlns:a16="http://schemas.microsoft.com/office/drawing/2014/main" id="{BBCA8CC0-1387-E35A-A0ED-93D34C0405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8954" y="3509803"/>
              <a:ext cx="436151" cy="2174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762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.2</a:t>
              </a:r>
              <a:endParaRPr lang="ja-JP" altLang="en-US" sz="762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17" name="Rectangle 49">
              <a:extLst>
                <a:ext uri="{FF2B5EF4-FFF2-40B4-BE49-F238E27FC236}">
                  <a16:creationId xmlns:a16="http://schemas.microsoft.com/office/drawing/2014/main" id="{E225FA72-D701-0609-EEA7-A3AB1B9366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6453" y="3974547"/>
              <a:ext cx="436151" cy="2174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762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.0</a:t>
              </a:r>
              <a:endParaRPr lang="ja-JP" altLang="en-US" sz="762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B30661CB-0005-159B-1895-4F731A106333}"/>
                </a:ext>
              </a:extLst>
            </p:cNvPr>
            <p:cNvCxnSpPr>
              <a:cxnSpLocks/>
            </p:cNvCxnSpPr>
            <p:nvPr/>
          </p:nvCxnSpPr>
          <p:spPr>
            <a:xfrm>
              <a:off x="1102784" y="1678568"/>
              <a:ext cx="0" cy="238406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972699CC-6BD5-C087-9AC9-EDA5502AC813}"/>
                </a:ext>
              </a:extLst>
            </p:cNvPr>
            <p:cNvCxnSpPr>
              <a:cxnSpLocks/>
            </p:cNvCxnSpPr>
            <p:nvPr/>
          </p:nvCxnSpPr>
          <p:spPr>
            <a:xfrm>
              <a:off x="1080290" y="4071621"/>
              <a:ext cx="3536887" cy="252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Rectangle 49">
              <a:extLst>
                <a:ext uri="{FF2B5EF4-FFF2-40B4-BE49-F238E27FC236}">
                  <a16:creationId xmlns:a16="http://schemas.microsoft.com/office/drawing/2014/main" id="{5DC657AF-FCA2-FCF3-7003-9B280DA8D6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4885" y="4127700"/>
              <a:ext cx="436151" cy="2174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762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</a:t>
              </a:r>
              <a:endParaRPr lang="ja-JP" altLang="en-US" sz="762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21" name="Rectangle 49">
              <a:extLst>
                <a:ext uri="{FF2B5EF4-FFF2-40B4-BE49-F238E27FC236}">
                  <a16:creationId xmlns:a16="http://schemas.microsoft.com/office/drawing/2014/main" id="{04D81796-D719-A33C-ADBE-FE62D76BDD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3123" y="4127700"/>
              <a:ext cx="436151" cy="2174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762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200</a:t>
              </a:r>
              <a:endParaRPr lang="ja-JP" altLang="en-US" sz="762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22" name="Rectangle 49">
              <a:extLst>
                <a:ext uri="{FF2B5EF4-FFF2-40B4-BE49-F238E27FC236}">
                  <a16:creationId xmlns:a16="http://schemas.microsoft.com/office/drawing/2014/main" id="{BD4A85AB-495A-FB70-41F3-82E42D8B57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0830" y="4152980"/>
              <a:ext cx="436151" cy="2174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762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400</a:t>
              </a:r>
              <a:endParaRPr lang="ja-JP" altLang="en-US" sz="762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23" name="Rectangle 49">
              <a:extLst>
                <a:ext uri="{FF2B5EF4-FFF2-40B4-BE49-F238E27FC236}">
                  <a16:creationId xmlns:a16="http://schemas.microsoft.com/office/drawing/2014/main" id="{BB8FAEDD-ED51-CCDB-36ED-5EA0F3B569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8278" y="4152980"/>
              <a:ext cx="436151" cy="2174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762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600</a:t>
              </a:r>
              <a:endParaRPr lang="ja-JP" altLang="en-US" sz="762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24" name="Rectangle 49">
              <a:extLst>
                <a:ext uri="{FF2B5EF4-FFF2-40B4-BE49-F238E27FC236}">
                  <a16:creationId xmlns:a16="http://schemas.microsoft.com/office/drawing/2014/main" id="{12A244B3-E36B-04BE-A929-2AD4EDC9C3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5681" y="4145665"/>
              <a:ext cx="436151" cy="2174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762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800</a:t>
              </a:r>
              <a:endParaRPr lang="ja-JP" altLang="en-US" sz="762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594EC0A5-862B-2AC4-CFC3-226EBE58ADD9}"/>
                </a:ext>
              </a:extLst>
            </p:cNvPr>
            <p:cNvSpPr txBox="1"/>
            <p:nvPr/>
          </p:nvSpPr>
          <p:spPr>
            <a:xfrm>
              <a:off x="1456600" y="1602762"/>
              <a:ext cx="3467285" cy="3885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62" i="1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D-L1 in macrophage Low </a:t>
              </a:r>
              <a:r>
                <a:rPr kumimoji="1" lang="en-US" altLang="ja-JP" sz="762" dirty="0">
                  <a:solidFill>
                    <a:schemeClr val="accent6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 = 30)</a:t>
              </a:r>
              <a:endParaRPr kumimoji="1" lang="ja-JP" altLang="en-US" sz="762" dirty="0">
                <a:solidFill>
                  <a:schemeClr val="accent6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79135D3F-B26B-519E-962F-A9A21618CD25}"/>
              </a:ext>
            </a:extLst>
          </p:cNvPr>
          <p:cNvGrpSpPr/>
          <p:nvPr/>
        </p:nvGrpSpPr>
        <p:grpSpPr>
          <a:xfrm>
            <a:off x="6109439" y="734925"/>
            <a:ext cx="2313820" cy="1983460"/>
            <a:chOff x="6125257" y="646759"/>
            <a:chExt cx="4823637" cy="3731056"/>
          </a:xfrm>
        </p:grpSpPr>
        <p:pic>
          <p:nvPicPr>
            <p:cNvPr id="27" name="図 26" descr="グラフ, 折れ線グラフ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F711DBC7-C211-7B25-7A21-F8571FE9639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5264" b="17471"/>
            <a:stretch>
              <a:fillRect/>
            </a:stretch>
          </p:blipFill>
          <p:spPr>
            <a:xfrm>
              <a:off x="6895361" y="1201664"/>
              <a:ext cx="3847005" cy="2544821"/>
            </a:xfrm>
            <a:prstGeom prst="rect">
              <a:avLst/>
            </a:prstGeom>
          </p:spPr>
        </p:pic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8BCFCE07-8D4B-5224-9A06-793B0E7D2A22}"/>
                </a:ext>
              </a:extLst>
            </p:cNvPr>
            <p:cNvSpPr txBox="1"/>
            <p:nvPr/>
          </p:nvSpPr>
          <p:spPr>
            <a:xfrm>
              <a:off x="7948913" y="716786"/>
              <a:ext cx="2951472" cy="4141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31" i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LA-A/B/C  Intact </a:t>
              </a:r>
              <a:r>
                <a:rPr kumimoji="1" lang="en-US" altLang="ja-JP" sz="83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 = 35)</a:t>
              </a:r>
              <a:endParaRPr kumimoji="1" lang="ja-JP" altLang="en-US" sz="83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E35983C3-5879-945E-E5B6-9BA1E1CE9FF7}"/>
                </a:ext>
              </a:extLst>
            </p:cNvPr>
            <p:cNvSpPr txBox="1"/>
            <p:nvPr/>
          </p:nvSpPr>
          <p:spPr>
            <a:xfrm>
              <a:off x="8027498" y="960377"/>
              <a:ext cx="2921396" cy="4141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31" i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LA-A/B/C Down </a:t>
              </a:r>
              <a:r>
                <a:rPr kumimoji="1" lang="en-US" altLang="ja-JP" sz="83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 = 10)</a:t>
              </a:r>
              <a:endParaRPr kumimoji="1" lang="ja-JP" altLang="en-US" sz="83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 Box 236">
              <a:extLst>
                <a:ext uri="{FF2B5EF4-FFF2-40B4-BE49-F238E27FC236}">
                  <a16:creationId xmlns:a16="http://schemas.microsoft.com/office/drawing/2014/main" id="{4C88ED27-9231-6831-DF0C-7103A0E85BF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568695" y="1638279"/>
              <a:ext cx="1203714" cy="414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831" b="1" i="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p = 0.04</a:t>
              </a:r>
              <a:endParaRPr lang="en-US" altLang="ja-JP" sz="831" b="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021C6359-7FE2-FECE-561E-B496DF71C9C9}"/>
                </a:ext>
              </a:extLst>
            </p:cNvPr>
            <p:cNvSpPr txBox="1"/>
            <p:nvPr/>
          </p:nvSpPr>
          <p:spPr>
            <a:xfrm rot="10800000">
              <a:off x="6125257" y="1576399"/>
              <a:ext cx="629461" cy="188039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kumimoji="1" lang="en-US" altLang="ja-JP" sz="762" b="1" dirty="0">
                  <a:latin typeface="Arial" panose="020B0604020202020204" pitchFamily="34" charset="0"/>
                  <a:cs typeface="Arial" panose="020B0604020202020204" pitchFamily="34" charset="0"/>
                </a:rPr>
                <a:t>Survival probability</a:t>
              </a:r>
              <a:endParaRPr kumimoji="1" lang="ja-JP" altLang="en-US" sz="7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167DF442-6AD1-24F7-230F-71A4EF754AAF}"/>
                </a:ext>
              </a:extLst>
            </p:cNvPr>
            <p:cNvSpPr txBox="1"/>
            <p:nvPr/>
          </p:nvSpPr>
          <p:spPr>
            <a:xfrm>
              <a:off x="6369558" y="646759"/>
              <a:ext cx="385110" cy="4542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kumimoji="1" lang="ja-JP" altLang="en-US" sz="96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F9D1C0FE-9F6E-0E88-5CA5-2A33456A5F9F}"/>
                </a:ext>
              </a:extLst>
            </p:cNvPr>
            <p:cNvCxnSpPr>
              <a:cxnSpLocks/>
            </p:cNvCxnSpPr>
            <p:nvPr/>
          </p:nvCxnSpPr>
          <p:spPr>
            <a:xfrm>
              <a:off x="6972058" y="3707560"/>
              <a:ext cx="3536887" cy="252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8C29F5AB-16A5-3144-8EA3-833647AE52E2}"/>
                </a:ext>
              </a:extLst>
            </p:cNvPr>
            <p:cNvCxnSpPr>
              <a:cxnSpLocks/>
            </p:cNvCxnSpPr>
            <p:nvPr/>
          </p:nvCxnSpPr>
          <p:spPr>
            <a:xfrm>
              <a:off x="6982928" y="1339342"/>
              <a:ext cx="0" cy="238406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Rectangle 49">
              <a:extLst>
                <a:ext uri="{FF2B5EF4-FFF2-40B4-BE49-F238E27FC236}">
                  <a16:creationId xmlns:a16="http://schemas.microsoft.com/office/drawing/2014/main" id="{350B1086-51A9-3211-7538-5D121CC2F7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53485" y="1259227"/>
              <a:ext cx="436152" cy="2405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1.0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36" name="Rectangle 49">
              <a:extLst>
                <a:ext uri="{FF2B5EF4-FFF2-40B4-BE49-F238E27FC236}">
                  <a16:creationId xmlns:a16="http://schemas.microsoft.com/office/drawing/2014/main" id="{E85B883D-C889-80DA-B51E-326B65BB0D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5547" y="1755591"/>
              <a:ext cx="436152" cy="2405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.8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37" name="Rectangle 49">
              <a:extLst>
                <a:ext uri="{FF2B5EF4-FFF2-40B4-BE49-F238E27FC236}">
                  <a16:creationId xmlns:a16="http://schemas.microsoft.com/office/drawing/2014/main" id="{EBBC4DAD-61B2-6456-AF87-B5DF0DC7C1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5547" y="2230783"/>
              <a:ext cx="436152" cy="2405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.6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38" name="Rectangle 49">
              <a:extLst>
                <a:ext uri="{FF2B5EF4-FFF2-40B4-BE49-F238E27FC236}">
                  <a16:creationId xmlns:a16="http://schemas.microsoft.com/office/drawing/2014/main" id="{A50C4B93-0D82-2AA8-6DAD-7292E0EAF8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2581" y="2696056"/>
              <a:ext cx="436152" cy="2405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.4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39" name="Rectangle 49">
              <a:extLst>
                <a:ext uri="{FF2B5EF4-FFF2-40B4-BE49-F238E27FC236}">
                  <a16:creationId xmlns:a16="http://schemas.microsoft.com/office/drawing/2014/main" id="{99E651F4-80EC-4E6E-6A9F-AF976B28E1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2583" y="3164700"/>
              <a:ext cx="436152" cy="2405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.2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40" name="Rectangle 49">
              <a:extLst>
                <a:ext uri="{FF2B5EF4-FFF2-40B4-BE49-F238E27FC236}">
                  <a16:creationId xmlns:a16="http://schemas.microsoft.com/office/drawing/2014/main" id="{37F29C4B-2B2F-6FE7-B157-E9979566B1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47018" y="3629447"/>
              <a:ext cx="436152" cy="2405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.0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CC7785E2-DC2B-E586-ED07-2707457C08EA}"/>
                </a:ext>
              </a:extLst>
            </p:cNvPr>
            <p:cNvSpPr txBox="1"/>
            <p:nvPr/>
          </p:nvSpPr>
          <p:spPr>
            <a:xfrm>
              <a:off x="7061476" y="3983523"/>
              <a:ext cx="3522917" cy="3942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62" b="1" dirty="0">
                  <a:latin typeface="Arial" panose="020B0604020202020204" pitchFamily="34" charset="0"/>
                  <a:cs typeface="Arial" panose="020B0604020202020204" pitchFamily="34" charset="0"/>
                </a:rPr>
                <a:t>Progression-free survival (Days)</a:t>
              </a:r>
              <a:endParaRPr kumimoji="1" lang="ja-JP" altLang="en-US" sz="7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Rectangle 49">
              <a:extLst>
                <a:ext uri="{FF2B5EF4-FFF2-40B4-BE49-F238E27FC236}">
                  <a16:creationId xmlns:a16="http://schemas.microsoft.com/office/drawing/2014/main" id="{B52D7CB0-266D-5AAF-8EC5-F8083D8183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74261" y="3780740"/>
              <a:ext cx="436152" cy="2405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43" name="Rectangle 49">
              <a:extLst>
                <a:ext uri="{FF2B5EF4-FFF2-40B4-BE49-F238E27FC236}">
                  <a16:creationId xmlns:a16="http://schemas.microsoft.com/office/drawing/2014/main" id="{0C642763-5F73-EA8E-B490-C5BCB261EB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02499" y="3780740"/>
              <a:ext cx="436152" cy="2405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200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44" name="Rectangle 49">
              <a:extLst>
                <a:ext uri="{FF2B5EF4-FFF2-40B4-BE49-F238E27FC236}">
                  <a16:creationId xmlns:a16="http://schemas.microsoft.com/office/drawing/2014/main" id="{EE7FAC8A-9EA5-BD4F-7333-EE36119035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40206" y="3806022"/>
              <a:ext cx="436152" cy="2405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400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45" name="Rectangle 49">
              <a:extLst>
                <a:ext uri="{FF2B5EF4-FFF2-40B4-BE49-F238E27FC236}">
                  <a16:creationId xmlns:a16="http://schemas.microsoft.com/office/drawing/2014/main" id="{A7298CEF-5F77-D71F-834C-6CF64DA876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47654" y="3806022"/>
              <a:ext cx="436152" cy="2405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600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46" name="Rectangle 49">
              <a:extLst>
                <a:ext uri="{FF2B5EF4-FFF2-40B4-BE49-F238E27FC236}">
                  <a16:creationId xmlns:a16="http://schemas.microsoft.com/office/drawing/2014/main" id="{0AAD4337-4DA7-6F1D-D3C2-0681D958B4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75058" y="3798704"/>
              <a:ext cx="436152" cy="2405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800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</p:grpSp>
      <p:grpSp>
        <p:nvGrpSpPr>
          <p:cNvPr id="68" name="グループ化 67">
            <a:extLst>
              <a:ext uri="{FF2B5EF4-FFF2-40B4-BE49-F238E27FC236}">
                <a16:creationId xmlns:a16="http://schemas.microsoft.com/office/drawing/2014/main" id="{26E607D9-8E62-E3B5-BCAD-29CF2619B48B}"/>
              </a:ext>
            </a:extLst>
          </p:cNvPr>
          <p:cNvGrpSpPr/>
          <p:nvPr/>
        </p:nvGrpSpPr>
        <p:grpSpPr>
          <a:xfrm>
            <a:off x="3817426" y="2518200"/>
            <a:ext cx="2368640" cy="2076721"/>
            <a:chOff x="1915929" y="646759"/>
            <a:chExt cx="4472788" cy="3741798"/>
          </a:xfrm>
        </p:grpSpPr>
        <p:pic>
          <p:nvPicPr>
            <p:cNvPr id="48" name="図 47" descr="グラフ, 折れ線グラフ&#10;&#10;AI 生成コンテンツは誤りを含む可能性があります。">
              <a:extLst>
                <a:ext uri="{FF2B5EF4-FFF2-40B4-BE49-F238E27FC236}">
                  <a16:creationId xmlns:a16="http://schemas.microsoft.com/office/drawing/2014/main" id="{12B7756C-D7CF-F9B9-A689-AAC4195709F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15745" b="15777"/>
            <a:stretch>
              <a:fillRect/>
            </a:stretch>
          </p:blipFill>
          <p:spPr>
            <a:xfrm>
              <a:off x="2652770" y="1320120"/>
              <a:ext cx="3675887" cy="2495760"/>
            </a:xfrm>
            <a:prstGeom prst="rect">
              <a:avLst/>
            </a:prstGeom>
          </p:spPr>
        </p:pic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BCADF3C8-5AF7-0340-B1B8-6E8384C02944}"/>
                </a:ext>
              </a:extLst>
            </p:cNvPr>
            <p:cNvSpPr txBox="1"/>
            <p:nvPr/>
          </p:nvSpPr>
          <p:spPr>
            <a:xfrm>
              <a:off x="2963623" y="4010887"/>
              <a:ext cx="3191073" cy="3776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62" b="1" dirty="0">
                  <a:latin typeface="Arial" panose="020B0604020202020204" pitchFamily="34" charset="0"/>
                  <a:cs typeface="Arial" panose="020B0604020202020204" pitchFamily="34" charset="0"/>
                </a:rPr>
                <a:t>Progression-free survival (Days)</a:t>
              </a:r>
              <a:endParaRPr kumimoji="1" lang="ja-JP" altLang="en-US" sz="7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8A9E7CDB-3CF2-CC92-DF9E-AE62527FDCD2}"/>
                </a:ext>
              </a:extLst>
            </p:cNvPr>
            <p:cNvSpPr txBox="1"/>
            <p:nvPr/>
          </p:nvSpPr>
          <p:spPr>
            <a:xfrm>
              <a:off x="3806074" y="2231113"/>
              <a:ext cx="2582643" cy="396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31" i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LA-DR positive </a:t>
              </a:r>
              <a:r>
                <a:rPr kumimoji="1" lang="en-US" altLang="ja-JP" sz="83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 = 11)</a:t>
              </a:r>
              <a:endParaRPr kumimoji="1" lang="ja-JP" altLang="en-US" sz="83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5971720F-AB99-20DA-CC20-61F9896C9953}"/>
                </a:ext>
              </a:extLst>
            </p:cNvPr>
            <p:cNvSpPr txBox="1"/>
            <p:nvPr/>
          </p:nvSpPr>
          <p:spPr>
            <a:xfrm>
              <a:off x="3303792" y="3049853"/>
              <a:ext cx="2661345" cy="396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31" i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LA-DR negative </a:t>
              </a:r>
              <a:r>
                <a:rPr kumimoji="1" lang="en-US" altLang="ja-JP" sz="83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n = 34)</a:t>
              </a:r>
              <a:endParaRPr kumimoji="1" lang="ja-JP" altLang="en-US" sz="83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2E69DB39-3A80-9D5E-F7EC-1BDDBCEA2E98}"/>
                </a:ext>
              </a:extLst>
            </p:cNvPr>
            <p:cNvSpPr txBox="1"/>
            <p:nvPr/>
          </p:nvSpPr>
          <p:spPr>
            <a:xfrm rot="10800000">
              <a:off x="1915929" y="1613282"/>
              <a:ext cx="570168" cy="180112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kumimoji="1" lang="en-US" altLang="ja-JP" sz="762" b="1" dirty="0">
                  <a:latin typeface="Arial" panose="020B0604020202020204" pitchFamily="34" charset="0"/>
                  <a:cs typeface="Arial" panose="020B0604020202020204" pitchFamily="34" charset="0"/>
                </a:rPr>
                <a:t>Survival probability</a:t>
              </a:r>
              <a:endParaRPr kumimoji="1" lang="ja-JP" altLang="en-US" sz="762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3806A89F-AFE1-9783-46F5-AC2393B9FB7C}"/>
                </a:ext>
              </a:extLst>
            </p:cNvPr>
            <p:cNvSpPr txBox="1"/>
            <p:nvPr/>
          </p:nvSpPr>
          <p:spPr>
            <a:xfrm>
              <a:off x="2018475" y="646759"/>
              <a:ext cx="348834" cy="4350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kumimoji="1" lang="ja-JP" altLang="en-US" sz="969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 Box 236">
              <a:extLst>
                <a:ext uri="{FF2B5EF4-FFF2-40B4-BE49-F238E27FC236}">
                  <a16:creationId xmlns:a16="http://schemas.microsoft.com/office/drawing/2014/main" id="{C35F3C12-B4F5-F99C-72F6-89CE2ED3723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99356" y="1701311"/>
              <a:ext cx="1090329" cy="3967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831" b="1" i="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p = 0.89</a:t>
              </a:r>
              <a:endParaRPr lang="en-US" altLang="ja-JP" sz="831" b="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55" name="Rectangle 49">
              <a:extLst>
                <a:ext uri="{FF2B5EF4-FFF2-40B4-BE49-F238E27FC236}">
                  <a16:creationId xmlns:a16="http://schemas.microsoft.com/office/drawing/2014/main" id="{5EB6481D-F620-0355-C45C-0D3AF98DC4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6872" y="1259558"/>
              <a:ext cx="436153" cy="230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1.0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56" name="Rectangle 49">
              <a:extLst>
                <a:ext uri="{FF2B5EF4-FFF2-40B4-BE49-F238E27FC236}">
                  <a16:creationId xmlns:a16="http://schemas.microsoft.com/office/drawing/2014/main" id="{E411D704-1463-CF00-F46D-9777832BC4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5867" y="1755916"/>
              <a:ext cx="436153" cy="230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.8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57" name="Rectangle 49">
              <a:extLst>
                <a:ext uri="{FF2B5EF4-FFF2-40B4-BE49-F238E27FC236}">
                  <a16:creationId xmlns:a16="http://schemas.microsoft.com/office/drawing/2014/main" id="{7D1AC8EE-DCCB-A49A-2402-264EAF10C5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5867" y="2231113"/>
              <a:ext cx="436153" cy="230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.6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58" name="Rectangle 49">
              <a:extLst>
                <a:ext uri="{FF2B5EF4-FFF2-40B4-BE49-F238E27FC236}">
                  <a16:creationId xmlns:a16="http://schemas.microsoft.com/office/drawing/2014/main" id="{D2C8F35E-E575-560A-2AAE-BD1626CD8C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2901" y="2696385"/>
              <a:ext cx="436153" cy="230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.4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59" name="Rectangle 49">
              <a:extLst>
                <a:ext uri="{FF2B5EF4-FFF2-40B4-BE49-F238E27FC236}">
                  <a16:creationId xmlns:a16="http://schemas.microsoft.com/office/drawing/2014/main" id="{DCFCE020-6217-8359-9785-21447A78E8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2901" y="3165028"/>
              <a:ext cx="436153" cy="230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.2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60" name="Rectangle 49">
              <a:extLst>
                <a:ext uri="{FF2B5EF4-FFF2-40B4-BE49-F238E27FC236}">
                  <a16:creationId xmlns:a16="http://schemas.microsoft.com/office/drawing/2014/main" id="{A2630828-0989-A29D-EA20-92CEF4EECB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0401" y="3629773"/>
              <a:ext cx="436153" cy="230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.0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cxnSp>
          <p:nvCxnSpPr>
            <p:cNvPr id="61" name="直線コネクタ 60">
              <a:extLst>
                <a:ext uri="{FF2B5EF4-FFF2-40B4-BE49-F238E27FC236}">
                  <a16:creationId xmlns:a16="http://schemas.microsoft.com/office/drawing/2014/main" id="{19754BD5-BC21-3B33-06D0-C9BE3BCF0C24}"/>
                </a:ext>
              </a:extLst>
            </p:cNvPr>
            <p:cNvCxnSpPr>
              <a:cxnSpLocks/>
            </p:cNvCxnSpPr>
            <p:nvPr/>
          </p:nvCxnSpPr>
          <p:spPr>
            <a:xfrm>
              <a:off x="2706731" y="1333794"/>
              <a:ext cx="0" cy="238406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4C370931-C513-1C04-F75F-D57C78E855BF}"/>
                </a:ext>
              </a:extLst>
            </p:cNvPr>
            <p:cNvCxnSpPr>
              <a:cxnSpLocks/>
            </p:cNvCxnSpPr>
            <p:nvPr/>
          </p:nvCxnSpPr>
          <p:spPr>
            <a:xfrm>
              <a:off x="2684237" y="3726847"/>
              <a:ext cx="3536887" cy="2521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Rectangle 49">
              <a:extLst>
                <a:ext uri="{FF2B5EF4-FFF2-40B4-BE49-F238E27FC236}">
                  <a16:creationId xmlns:a16="http://schemas.microsoft.com/office/drawing/2014/main" id="{04D24742-7766-B548-7750-90EC94ABA1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8831" y="3782926"/>
              <a:ext cx="436153" cy="230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0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64" name="Rectangle 49">
              <a:extLst>
                <a:ext uri="{FF2B5EF4-FFF2-40B4-BE49-F238E27FC236}">
                  <a16:creationId xmlns:a16="http://schemas.microsoft.com/office/drawing/2014/main" id="{40B99593-F32A-031A-1457-9951A258D4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7070" y="3782926"/>
              <a:ext cx="436153" cy="230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200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65" name="Rectangle 49">
              <a:extLst>
                <a:ext uri="{FF2B5EF4-FFF2-40B4-BE49-F238E27FC236}">
                  <a16:creationId xmlns:a16="http://schemas.microsoft.com/office/drawing/2014/main" id="{AE2A6C43-79E1-73BE-24C6-6F44DE1DE8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4777" y="3808207"/>
              <a:ext cx="436153" cy="230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400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66" name="Rectangle 49">
              <a:extLst>
                <a:ext uri="{FF2B5EF4-FFF2-40B4-BE49-F238E27FC236}">
                  <a16:creationId xmlns:a16="http://schemas.microsoft.com/office/drawing/2014/main" id="{6018A4B8-671D-A0A4-69DA-14419CF70D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2225" y="3808207"/>
              <a:ext cx="436153" cy="230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600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  <p:sp>
          <p:nvSpPr>
            <p:cNvPr id="67" name="Rectangle 49">
              <a:extLst>
                <a:ext uri="{FF2B5EF4-FFF2-40B4-BE49-F238E27FC236}">
                  <a16:creationId xmlns:a16="http://schemas.microsoft.com/office/drawing/2014/main" id="{F6617934-661A-73BB-396F-086770B7E8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9629" y="3800891"/>
              <a:ext cx="436153" cy="230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ja-JP" sz="831" dirty="0">
                  <a:latin typeface="Arial" pitchFamily="34" charset="0"/>
                  <a:ea typeface="ＭＳ Ｐゴシック" charset="-128"/>
                  <a:cs typeface="Arial" pitchFamily="34" charset="0"/>
                </a:rPr>
                <a:t>800</a:t>
              </a:r>
              <a:endParaRPr lang="ja-JP" altLang="en-US" sz="831" dirty="0">
                <a:latin typeface="Arial" pitchFamily="34" charset="0"/>
                <a:ea typeface="ＭＳ Ｐゴシック" charset="-128"/>
                <a:cs typeface="Arial" pitchFamily="34" charset="0"/>
              </a:endParaRPr>
            </a:p>
          </p:txBody>
        </p:sp>
      </p:grp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80A5922E-1A51-78EE-7CA7-B1D91F11EAD8}"/>
              </a:ext>
            </a:extLst>
          </p:cNvPr>
          <p:cNvSpPr txBox="1"/>
          <p:nvPr/>
        </p:nvSpPr>
        <p:spPr>
          <a:xfrm>
            <a:off x="3968396" y="4892597"/>
            <a:ext cx="3865319" cy="9044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554"/>
              </a:spcAft>
            </a:pPr>
            <a:r>
              <a:rPr lang="en-US" altLang="ja-JP" sz="831" b="1" kern="100" dirty="0">
                <a:latin typeface="Arial" panose="020B0604020202020204" pitchFamily="34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orting Figure 1. The association of immune markers and progression free survival time. </a:t>
            </a:r>
          </a:p>
          <a:p>
            <a:pPr>
              <a:lnSpc>
                <a:spcPct val="115000"/>
              </a:lnSpc>
              <a:spcAft>
                <a:spcPts val="554"/>
              </a:spcAft>
            </a:pPr>
            <a:r>
              <a:rPr lang="en-US" altLang="ja-JP" sz="831" dirty="0"/>
              <a:t>Kaplan–Meier analyses was performed to test the correlation of PD-L1 and HLA expression status in progression-free survival (PFS). P value was evaluated by log-rank test. </a:t>
            </a:r>
            <a:endParaRPr lang="ja-JP" altLang="ja-JP" sz="831" kern="100" dirty="0">
              <a:latin typeface="Calibri" panose="020F0502020204030204" pitchFamily="34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2102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79E7D5F-E325-8FF1-010F-125BFD58EF8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A4EF93A-0ECB-30E6-722F-082F2263BA06}"/>
              </a:ext>
            </a:extLst>
          </p:cNvPr>
          <p:cNvSpPr txBox="1"/>
          <p:nvPr/>
        </p:nvSpPr>
        <p:spPr>
          <a:xfrm>
            <a:off x="3772690" y="92713"/>
            <a:ext cx="1431289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46" dirty="0"/>
              <a:t>Supporting figure 2</a:t>
            </a:r>
            <a:endParaRPr kumimoji="1" lang="ja-JP" altLang="en-US" sz="1246" dirty="0"/>
          </a:p>
        </p:txBody>
      </p:sp>
      <p:pic>
        <p:nvPicPr>
          <p:cNvPr id="32" name="Picture 3">
            <a:extLst>
              <a:ext uri="{FF2B5EF4-FFF2-40B4-BE49-F238E27FC236}">
                <a16:creationId xmlns:a16="http://schemas.microsoft.com/office/drawing/2014/main" id="{97CB32AC-6347-52E5-E265-38119EBA236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059056" y="1145225"/>
            <a:ext cx="1122859" cy="1122859"/>
          </a:xfrm>
          <a:prstGeom prst="rect">
            <a:avLst/>
          </a:prstGeom>
        </p:spPr>
      </p:pic>
      <p:pic>
        <p:nvPicPr>
          <p:cNvPr id="33" name="Picture 11">
            <a:extLst>
              <a:ext uri="{FF2B5EF4-FFF2-40B4-BE49-F238E27FC236}">
                <a16:creationId xmlns:a16="http://schemas.microsoft.com/office/drawing/2014/main" id="{63346DB9-07A6-0CF9-4C1B-7CA97A40F1A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3969" y="1121291"/>
            <a:ext cx="1398612" cy="1271466"/>
          </a:xfrm>
          <a:prstGeom prst="rect">
            <a:avLst/>
          </a:prstGeom>
        </p:spPr>
      </p:pic>
      <p:pic>
        <p:nvPicPr>
          <p:cNvPr id="34" name="Picture 13">
            <a:extLst>
              <a:ext uri="{FF2B5EF4-FFF2-40B4-BE49-F238E27FC236}">
                <a16:creationId xmlns:a16="http://schemas.microsoft.com/office/drawing/2014/main" id="{DDEF0C09-FC66-BD85-4BBD-1988F860A72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2581" y="1121680"/>
            <a:ext cx="1398185" cy="1271077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DBAF470-13D6-5D24-C17C-09A8BE8E147C}"/>
              </a:ext>
            </a:extLst>
          </p:cNvPr>
          <p:cNvSpPr txBox="1"/>
          <p:nvPr/>
        </p:nvSpPr>
        <p:spPr>
          <a:xfrm>
            <a:off x="3874927" y="2464707"/>
            <a:ext cx="3865319" cy="7573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554"/>
              </a:spcAft>
            </a:pPr>
            <a:r>
              <a:rPr lang="en-US" altLang="ja-JP" sz="831" b="1" kern="100" dirty="0">
                <a:latin typeface="Arial" panose="020B0604020202020204" pitchFamily="34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upporting Figure 2. The association of PD-L1+ and SPP1+ TAMs in esophageal cancer. </a:t>
            </a:r>
            <a:endParaRPr lang="ja-JP" altLang="ja-JP" sz="831" kern="100" dirty="0">
              <a:latin typeface="Calibri" panose="020F0502020204030204" pitchFamily="34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554"/>
              </a:spcAft>
            </a:pPr>
            <a:r>
              <a:rPr lang="en-US" altLang="ja-JP" sz="831" kern="100" dirty="0">
                <a:latin typeface="Arial" panose="020B0604020202020204" pitchFamily="34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ingle cell RNA-sequence data of figure 5 was re-analyzed. </a:t>
            </a:r>
            <a:r>
              <a:rPr lang="en-GB" altLang="ja-JP" sz="831" kern="100" dirty="0">
                <a:latin typeface="Arial" panose="020B0604020202020204" pitchFamily="34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UMAP plot of the TAMs and their expression of SPP1 and CD274 (PD-L1).</a:t>
            </a:r>
            <a:endParaRPr lang="ja-JP" altLang="ja-JP" sz="831" kern="100" dirty="0">
              <a:latin typeface="Calibri" panose="020F0502020204030204" pitchFamily="34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4B6242C-515B-44B2-F30F-E995BA7EB5BE}"/>
              </a:ext>
            </a:extLst>
          </p:cNvPr>
          <p:cNvSpPr txBox="1"/>
          <p:nvPr/>
        </p:nvSpPr>
        <p:spPr>
          <a:xfrm>
            <a:off x="5961090" y="1049340"/>
            <a:ext cx="383843" cy="3480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31" i="1" dirty="0"/>
              <a:t>SPP1</a:t>
            </a:r>
            <a:endParaRPr kumimoji="1" lang="ja-JP" altLang="en-US" sz="831" i="1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FF5BFA9-CBA9-07B6-433C-A4CE1DADE119}"/>
              </a:ext>
            </a:extLst>
          </p:cNvPr>
          <p:cNvSpPr txBox="1"/>
          <p:nvPr/>
        </p:nvSpPr>
        <p:spPr>
          <a:xfrm>
            <a:off x="7235889" y="1049340"/>
            <a:ext cx="419376" cy="3480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831" i="1" dirty="0"/>
              <a:t>CD274</a:t>
            </a:r>
            <a:endParaRPr kumimoji="1" lang="ja-JP" altLang="en-US" sz="831" i="1" dirty="0"/>
          </a:p>
        </p:txBody>
      </p:sp>
    </p:spTree>
    <p:extLst>
      <p:ext uri="{BB962C8B-B14F-4D97-AF65-F5344CB8AC3E}">
        <p14:creationId xmlns:p14="http://schemas.microsoft.com/office/powerpoint/2010/main" val="28014051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1</Words>
  <Application>Microsoft Office PowerPoint</Application>
  <PresentationFormat>Widescreen</PresentationFormat>
  <Paragraphs>5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ＭＳ Ｐゴシック</vt:lpstr>
      <vt:lpstr>游ゴシック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vya Ganesan</dc:creator>
  <cp:lastModifiedBy>Divya Ganesan</cp:lastModifiedBy>
  <cp:revision>1</cp:revision>
  <dcterms:created xsi:type="dcterms:W3CDTF">2026-04-17T14:25:53Z</dcterms:created>
  <dcterms:modified xsi:type="dcterms:W3CDTF">2026-04-17T14:26:06Z</dcterms:modified>
</cp:coreProperties>
</file>